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3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1536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2/02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233807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51931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545286"/>
            <a:ext cx="77048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McNeilly and McCrimmon</a:t>
            </a:r>
            <a:r>
              <a:rPr lang="en-GB" baseline="30000" dirty="0"/>
              <a:t> </a:t>
            </a:r>
            <a:r>
              <a:rPr lang="en-GB" dirty="0"/>
              <a:t>(2018) Diabetologia DOI 10.1007/s00125-018-4548-8  </a:t>
            </a:r>
          </a:p>
          <a:p>
            <a:r>
              <a:rPr lang="en-GB" sz="1200" dirty="0"/>
              <a:t>© The Authors </a:t>
            </a:r>
            <a:r>
              <a:rPr lang="en-GB" sz="1200" dirty="0" smtClean="0"/>
              <a:t>2018. Distributed </a:t>
            </a:r>
            <a:r>
              <a:rPr lang="en-GB" sz="1200" dirty="0"/>
              <a:t>under the terms of the </a:t>
            </a:r>
            <a:r>
              <a:rPr lang="en-GB" sz="1200" dirty="0" smtClean="0"/>
              <a:t>CC BY 4.0 Attribution License (</a:t>
            </a:r>
            <a:r>
              <a:rPr lang="en-GB" sz="1200" dirty="0"/>
              <a:t>http://creativecommons.org/licenses/by/4.0</a:t>
            </a:r>
            <a:r>
              <a:rPr lang="en-GB" sz="1200" dirty="0" smtClean="0"/>
              <a:t>/)</a:t>
            </a:r>
            <a:endParaRPr lang="en-GB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/>
              <a:t>Counterregulatory</a:t>
            </a:r>
            <a:r>
              <a:rPr lang="en-GB" sz="2000" b="1" dirty="0"/>
              <a:t> failure in type 1 diabetes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1520" y="1484784"/>
            <a:ext cx="8589135" cy="3791937"/>
          </a:xfrm>
          <a:prstGeom prst="rect">
            <a:avLst/>
          </a:prstGeom>
        </p:spPr>
      </p:pic>
      <p:grpSp>
        <p:nvGrpSpPr>
          <p:cNvPr id="17" name="Group 16"/>
          <p:cNvGrpSpPr/>
          <p:nvPr/>
        </p:nvGrpSpPr>
        <p:grpSpPr>
          <a:xfrm>
            <a:off x="6911752" y="260648"/>
            <a:ext cx="2232248" cy="1485275"/>
            <a:chOff x="6804248" y="197836"/>
            <a:chExt cx="2232248" cy="1485275"/>
          </a:xfrm>
        </p:grpSpPr>
        <p:grpSp>
          <p:nvGrpSpPr>
            <p:cNvPr id="15" name="Group 14"/>
            <p:cNvGrpSpPr/>
            <p:nvPr/>
          </p:nvGrpSpPr>
          <p:grpSpPr>
            <a:xfrm>
              <a:off x="6951095" y="260648"/>
              <a:ext cx="2085401" cy="1422463"/>
              <a:chOff x="6991538" y="380550"/>
              <a:chExt cx="2085401" cy="1422463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 flipH="1">
                <a:off x="6991538" y="380550"/>
                <a:ext cx="258363" cy="294034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998303" y="812598"/>
                <a:ext cx="262723" cy="306424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 flipH="1">
                <a:off x="6996045" y="1249683"/>
                <a:ext cx="264026" cy="282995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7204731" y="387241"/>
                <a:ext cx="1872208" cy="14157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No diabetes</a:t>
                </a:r>
              </a:p>
              <a:p>
                <a:endParaRPr lang="en-GB" sz="1000" dirty="0"/>
              </a:p>
              <a:p>
                <a:r>
                  <a:rPr lang="en-GB" sz="1200" dirty="0"/>
                  <a:t>Conventionally treated type 1 diabetes</a:t>
                </a:r>
              </a:p>
              <a:p>
                <a:endParaRPr lang="en-GB" sz="1000" dirty="0"/>
              </a:p>
              <a:p>
                <a:r>
                  <a:rPr lang="en-GB" sz="1200" dirty="0"/>
                  <a:t>Intensive insulin therapy</a:t>
                </a:r>
              </a:p>
              <a:p>
                <a:endParaRPr lang="en-GB" dirty="0"/>
              </a:p>
            </p:txBody>
          </p:sp>
        </p:grpSp>
        <p:sp>
          <p:nvSpPr>
            <p:cNvPr id="16" name="Rounded Rectangle 15"/>
            <p:cNvSpPr/>
            <p:nvPr/>
          </p:nvSpPr>
          <p:spPr>
            <a:xfrm>
              <a:off x="6804248" y="197836"/>
              <a:ext cx="2107200" cy="1296144"/>
            </a:xfrm>
            <a:prstGeom prst="roundRect">
              <a:avLst/>
            </a:prstGeom>
            <a:noFill/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30548" y="5872916"/>
            <a:ext cx="799288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cNeilly and McCrimmon</a:t>
            </a:r>
            <a:r>
              <a:rPr lang="en-GB" baseline="30000" dirty="0"/>
              <a:t> </a:t>
            </a:r>
            <a:r>
              <a:rPr lang="en-GB" dirty="0"/>
              <a:t>(2018) Diabetologia DOI 10.1007/s00125-018-4548-8  </a:t>
            </a:r>
          </a:p>
          <a:p>
            <a:r>
              <a:rPr lang="en-GB" sz="1200" dirty="0"/>
              <a:t>© The Authors 2018. Distributed under the terms of the CC BY 4.0 Attribution License (http://creativecommons.org/licenses/by/4.0/)</a:t>
            </a:r>
          </a:p>
          <a:p>
            <a:endParaRPr lang="en-GB" sz="14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otential mechanisms underlying the development of impaired awareness of hypoglycaemia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4785" y="1293595"/>
            <a:ext cx="7550454" cy="43810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4167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grpSp>
        <p:nvGrpSpPr>
          <p:cNvPr id="59" name="Group 58"/>
          <p:cNvGrpSpPr/>
          <p:nvPr/>
        </p:nvGrpSpPr>
        <p:grpSpPr>
          <a:xfrm>
            <a:off x="1259632" y="127513"/>
            <a:ext cx="6752153" cy="6777392"/>
            <a:chOff x="1259632" y="127513"/>
            <a:chExt cx="6752153" cy="6777392"/>
          </a:xfrm>
        </p:grpSpPr>
        <p:sp>
          <p:nvSpPr>
            <p:cNvPr id="5" name="Rectangle 4"/>
            <p:cNvSpPr/>
            <p:nvPr/>
          </p:nvSpPr>
          <p:spPr>
            <a:xfrm>
              <a:off x="2509604" y="3275171"/>
              <a:ext cx="1086662" cy="30886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54" name="Group 53"/>
            <p:cNvGrpSpPr/>
            <p:nvPr/>
          </p:nvGrpSpPr>
          <p:grpSpPr>
            <a:xfrm>
              <a:off x="1259632" y="332656"/>
              <a:ext cx="6752153" cy="6572249"/>
              <a:chOff x="1259632" y="332656"/>
              <a:chExt cx="6752153" cy="6572249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1348239" y="332656"/>
                <a:ext cx="6663546" cy="6572249"/>
                <a:chOff x="3225800" y="416955"/>
                <a:chExt cx="6663546" cy="6572249"/>
              </a:xfrm>
            </p:grpSpPr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225800" y="1308100"/>
                  <a:ext cx="5740400" cy="4241800"/>
                </a:xfrm>
                <a:prstGeom prst="rect">
                  <a:avLst/>
                </a:prstGeom>
              </p:spPr>
            </p:pic>
            <p:sp>
              <p:nvSpPr>
                <p:cNvPr id="10" name="TextBox 9"/>
                <p:cNvSpPr txBox="1"/>
                <p:nvPr/>
              </p:nvSpPr>
              <p:spPr>
                <a:xfrm rot="16200000">
                  <a:off x="5055327" y="1562970"/>
                  <a:ext cx="2569029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IR (mg kg</a:t>
                  </a:r>
                  <a:r>
                    <a:rPr lang="en-GB" sz="12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−1 </a:t>
                  </a:r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n</a:t>
                  </a:r>
                  <a:r>
                    <a:rPr lang="en-GB" sz="12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−1</a:t>
                  </a:r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r>
                    <a:rPr lang="en-GB" sz="12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 rot="16200000">
                  <a:off x="2113466" y="3671954"/>
                  <a:ext cx="2569029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pinephrine (</a:t>
                  </a:r>
                  <a:r>
                    <a:rPr lang="en-GB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mol</a:t>
                  </a:r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l)</a:t>
                  </a:r>
                  <a:r>
                    <a:rPr lang="en-GB" sz="12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 rot="16200000">
                  <a:off x="2559039" y="2008541"/>
                  <a:ext cx="167788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ucose (</a:t>
                  </a:r>
                  <a:r>
                    <a:rPr lang="en-GB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mol</a:t>
                  </a:r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l)</a:t>
                  </a: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 rot="16200000">
                  <a:off x="5452837" y="4014981"/>
                  <a:ext cx="1756592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ucagon (</a:t>
                  </a:r>
                  <a:r>
                    <a:rPr lang="en-GB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g</a:t>
                  </a:r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ml)</a:t>
                  </a:r>
                  <a:r>
                    <a:rPr lang="en-GB" sz="12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4294088" y="3275111"/>
                  <a:ext cx="2569029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ime (min)</a:t>
                  </a: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7320317" y="3094407"/>
                  <a:ext cx="2569029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ime (min)</a:t>
                  </a: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 rot="18761871">
                  <a:off x="2490713" y="5767611"/>
                  <a:ext cx="2054911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en-GB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 rot="18761871">
                  <a:off x="3113949" y="5810397"/>
                  <a:ext cx="2137339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GB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H + LI</a:t>
                  </a:r>
                  <a:endParaRPr lang="en-GB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 rot="18761871">
                  <a:off x="3926686" y="5782028"/>
                  <a:ext cx="2026117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H + HI</a:t>
                  </a:r>
                  <a:endParaRPr lang="en-GB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 rot="18761871">
                  <a:off x="5416297" y="5754063"/>
                  <a:ext cx="1984034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en-GB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 rot="18761871">
                  <a:off x="5972771" y="5817941"/>
                  <a:ext cx="2157861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GB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H + LI</a:t>
                  </a:r>
                  <a:endParaRPr lang="en-GB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 rot="18761871">
                  <a:off x="6787258" y="5768821"/>
                  <a:ext cx="2024188" cy="1846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H + HI</a:t>
                  </a:r>
                  <a:endParaRPr lang="en-GB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6" name="Rectangle 35"/>
              <p:cNvSpPr/>
              <p:nvPr/>
            </p:nvSpPr>
            <p:spPr>
              <a:xfrm>
                <a:off x="1259632" y="1412776"/>
                <a:ext cx="3055440" cy="205195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1418116" y="127513"/>
              <a:ext cx="3637317" cy="3135156"/>
              <a:chOff x="3225800" y="416954"/>
              <a:chExt cx="3637317" cy="3135156"/>
            </a:xfrm>
          </p:grpSpPr>
          <p:pic>
            <p:nvPicPr>
              <p:cNvPr id="56" name="Picture 55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1078" b="48013"/>
              <a:stretch/>
            </p:blipFill>
            <p:spPr>
              <a:xfrm>
                <a:off x="3225800" y="1308100"/>
                <a:ext cx="2808312" cy="2205198"/>
              </a:xfrm>
              <a:prstGeom prst="rect">
                <a:avLst/>
              </a:prstGeom>
            </p:spPr>
          </p:pic>
          <p:sp>
            <p:nvSpPr>
              <p:cNvPr id="57" name="TextBox 56"/>
              <p:cNvSpPr txBox="1"/>
              <p:nvPr/>
            </p:nvSpPr>
            <p:spPr>
              <a:xfrm rot="16200000">
                <a:off x="2113466" y="1562969"/>
                <a:ext cx="256902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lucose (</a:t>
                </a:r>
                <a:r>
                  <a:rPr lang="en-GB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mol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/l)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4294088" y="3275111"/>
                <a:ext cx="256902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min)</a:t>
                </a:r>
              </a:p>
            </p:txBody>
          </p:sp>
        </p:grpSp>
      </p:grp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Dishabituation with high-intensity exercis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51520" y="5589240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McNeilly and McCrimmon</a:t>
            </a:r>
            <a:r>
              <a:rPr lang="en-GB" baseline="30000" dirty="0"/>
              <a:t> </a:t>
            </a:r>
            <a:r>
              <a:rPr lang="en-GB" dirty="0"/>
              <a:t>(2018) Diabetologia DOI 10.1007/s00125-018-4548-8 </a:t>
            </a:r>
          </a:p>
          <a:p>
            <a:r>
              <a:rPr lang="en-GB" sz="1200" dirty="0"/>
              <a:t>© ADA. Adapted with permission from </a:t>
            </a:r>
            <a:r>
              <a:rPr lang="en-GB" sz="1200" dirty="0" err="1"/>
              <a:t>McNeilly</a:t>
            </a:r>
            <a:r>
              <a:rPr lang="en-GB" sz="1200" dirty="0"/>
              <a:t> et al (2017)</a:t>
            </a:r>
          </a:p>
        </p:txBody>
      </p:sp>
    </p:spTree>
    <p:extLst>
      <p:ext uri="{BB962C8B-B14F-4D97-AF65-F5344CB8AC3E}">
        <p14:creationId xmlns:p14="http://schemas.microsoft.com/office/powerpoint/2010/main" val="3335302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</TotalTime>
  <Words>167</Words>
  <Application>Microsoft Office PowerPoint</Application>
  <PresentationFormat>On-screen Show (4:3)</PresentationFormat>
  <Paragraphs>33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2</cp:revision>
  <dcterms:created xsi:type="dcterms:W3CDTF">2016-06-15T12:53:43Z</dcterms:created>
  <dcterms:modified xsi:type="dcterms:W3CDTF">2018-02-02T11:23:36Z</dcterms:modified>
</cp:coreProperties>
</file>